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8" r:id="rId5"/>
    <p:sldId id="263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516" y="12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828800" y="304800"/>
            <a:ext cx="5715000" cy="4953000"/>
            <a:chOff x="309813" y="109017"/>
            <a:chExt cx="6090987" cy="7086130"/>
          </a:xfrm>
        </p:grpSpPr>
        <p:pic>
          <p:nvPicPr>
            <p:cNvPr id="2" name="Picture 1" descr="Broilern (1).jpeg"/>
            <p:cNvPicPr>
              <a:picLocks noChangeAspect="1"/>
            </p:cNvPicPr>
            <p:nvPr/>
          </p:nvPicPr>
          <p:blipFill>
            <a:blip r:embed="rId2" cstate="print"/>
            <a:srcRect l="23936" t="1515" r="30833"/>
            <a:stretch>
              <a:fillRect/>
            </a:stretch>
          </p:blipFill>
          <p:spPr>
            <a:xfrm>
              <a:off x="309813" y="109017"/>
              <a:ext cx="6090987" cy="708613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4648200" y="6705600"/>
              <a:ext cx="1237358" cy="4514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 smtClean="0">
                  <a:latin typeface="Times New Roman" pitchFamily="18" charset="0"/>
                  <a:cs typeface="Times New Roman" pitchFamily="18" charset="0"/>
                </a:rPr>
                <a:t>K_Archaea_0.3%</a:t>
              </a:r>
              <a:endParaRPr lang="en-US" sz="1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1600200" y="5486400"/>
            <a:ext cx="573054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 S1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Kron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hart of taxonomic assignments.</a:t>
            </a:r>
          </a:p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Mean relative abundance of the prokaryotes at different taxonomic</a:t>
            </a:r>
          </a:p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levels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ar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hown as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Kron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harts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or 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the broiler line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676400" y="5562600"/>
            <a:ext cx="573054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 S1b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Kron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hart of taxonomic assignments.</a:t>
            </a:r>
          </a:p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Mean relative abundance of the prokaryotes at different taxonomic</a:t>
            </a:r>
          </a:p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levels  ar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hown as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Kron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harts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or 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Aseel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breed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981200" y="304800"/>
            <a:ext cx="5029200" cy="5029200"/>
            <a:chOff x="381000" y="331362"/>
            <a:chExt cx="5626274" cy="6268460"/>
          </a:xfrm>
        </p:grpSpPr>
        <p:pic>
          <p:nvPicPr>
            <p:cNvPr id="6" name="Picture 5" descr="snapshot_aseeln.jpeg"/>
            <p:cNvPicPr>
              <a:picLocks noChangeAspect="1"/>
            </p:cNvPicPr>
            <p:nvPr/>
          </p:nvPicPr>
          <p:blipFill>
            <a:blip r:embed="rId2" cstate="print"/>
            <a:srcRect l="26667" t="6069" r="33911" b="2650"/>
            <a:stretch>
              <a:fillRect/>
            </a:stretch>
          </p:blipFill>
          <p:spPr>
            <a:xfrm>
              <a:off x="381000" y="331362"/>
              <a:ext cx="5626274" cy="6268460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3837140" y="6086014"/>
              <a:ext cx="1318967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K_Archaea_0.9%</a:t>
              </a:r>
              <a:endParaRPr lang="en-US" dirty="0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76400" y="5486400"/>
            <a:ext cx="573054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 S1c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Kron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hart of taxonomic assignments.</a:t>
            </a:r>
          </a:p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Mean relative abundance of the prokaryotes at different taxonomic</a:t>
            </a:r>
          </a:p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levels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ar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hown as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Kron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harts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or the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Ghagu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breed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981199" y="285750"/>
            <a:ext cx="5410201" cy="4857750"/>
            <a:chOff x="457200" y="381000"/>
            <a:chExt cx="5867400" cy="6477000"/>
          </a:xfrm>
        </p:grpSpPr>
        <p:pic>
          <p:nvPicPr>
            <p:cNvPr id="3" name="Picture 2" descr="Ghagusn (1).jpeg"/>
            <p:cNvPicPr>
              <a:picLocks noChangeAspect="1"/>
            </p:cNvPicPr>
            <p:nvPr/>
          </p:nvPicPr>
          <p:blipFill>
            <a:blip r:embed="rId2" cstate="print"/>
            <a:srcRect l="26667" t="4573" r="30000"/>
            <a:stretch>
              <a:fillRect/>
            </a:stretch>
          </p:blipFill>
          <p:spPr>
            <a:xfrm>
              <a:off x="457200" y="381000"/>
              <a:ext cx="5867400" cy="64770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4724400" y="6324600"/>
              <a:ext cx="1236011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K_Archea_1.0%</a:t>
              </a:r>
              <a:endParaRPr lang="en-US" dirty="0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09800" y="304800"/>
            <a:ext cx="5257800" cy="5181600"/>
            <a:chOff x="539262" y="216000"/>
            <a:chExt cx="5855676" cy="6642000"/>
          </a:xfrm>
        </p:grpSpPr>
        <p:pic>
          <p:nvPicPr>
            <p:cNvPr id="3" name="Picture 2" descr="Nicobarin.jpeg"/>
            <p:cNvPicPr>
              <a:picLocks noChangeAspect="1"/>
            </p:cNvPicPr>
            <p:nvPr/>
          </p:nvPicPr>
          <p:blipFill>
            <a:blip r:embed="rId2" cstate="print"/>
            <a:srcRect l="28832" t="7579" r="32165"/>
            <a:stretch>
              <a:fillRect/>
            </a:stretch>
          </p:blipFill>
          <p:spPr>
            <a:xfrm>
              <a:off x="539262" y="216000"/>
              <a:ext cx="5855676" cy="66420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4572000" y="6248400"/>
              <a:ext cx="1318967" cy="492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K_Archaea_0.6%</a:t>
              </a:r>
              <a:endParaRPr lang="en-US" dirty="0"/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2057400" y="5562600"/>
            <a:ext cx="573054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ure S1d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Kron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hart of taxonomic assignments.</a:t>
            </a:r>
          </a:p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Mean relative abundance of the prokaryotes at different taxonomic</a:t>
            </a:r>
          </a:p>
          <a:p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levels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ar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shown as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Krona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harts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for the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Nicobari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breed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taxa_alpha_17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57200" y="367393"/>
            <a:ext cx="8229600" cy="511900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33400" y="6096000"/>
            <a:ext cx="84160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S1e</a:t>
            </a:r>
            <a:r>
              <a:rPr lang="en-US" dirty="0" smtClean="0"/>
              <a:t>. Stacked bar plots of taxonomic assignments. Mean relative abundance of </a:t>
            </a:r>
          </a:p>
          <a:p>
            <a:r>
              <a:rPr lang="en-US" dirty="0" smtClean="0"/>
              <a:t>Prokaryotes in different breeds or lines at phylum level are shown as stacked bar plots</a:t>
            </a:r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157</Words>
  <Application>Microsoft Office PowerPoint</Application>
  <PresentationFormat>On-screen Show (4:3)</PresentationFormat>
  <Paragraphs>18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10</cp:revision>
  <dcterms:created xsi:type="dcterms:W3CDTF">2006-08-16T00:00:00Z</dcterms:created>
  <dcterms:modified xsi:type="dcterms:W3CDTF">2021-01-24T10:17:30Z</dcterms:modified>
</cp:coreProperties>
</file>